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A8EE1E-5689-4212-80DD-FA0FA4DFEC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EB990F-19D4-4146-AAB5-8C49A44B7F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57AAE9-69A7-4140-9024-BA9E131C516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040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4672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08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040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4672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E639AE-90E6-4CF2-AAAE-181401A546C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B1F33-D79C-4633-B392-A2D5749B05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EDC0C6-C7CB-417C-BEAE-9E9DB29749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4ED5EC-846A-4257-91F5-CD9E720DE7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EBFD1A-FBBC-4756-AF69-5313A2E58F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080" y="812520"/>
            <a:ext cx="5815080" cy="699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689AEF-15A3-4020-83EF-FB3BADB859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947E44-0050-4048-8E20-AB6A67C17B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75622A-FD2E-4BE3-9A06-B74D867290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9FA454-B2F9-4426-996B-A7BF82A8B2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2880" y="8331120"/>
            <a:ext cx="215748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defRPr>
            </a:lvl1pPr>
          </a:lstStyle>
          <a:p>
            <a: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76859CC1-CA29-476B-9716-05CCFDCB832F}" type="slidenum">
              <a: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&lt;number&gt;</a:t>
            </a:fld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"/>
          <p:cNvSpPr/>
          <p:nvPr/>
        </p:nvSpPr>
        <p:spPr>
          <a:xfrm>
            <a:off x="0" y="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A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2" name="Text Box 2"/>
          <p:cNvSpPr/>
          <p:nvPr/>
        </p:nvSpPr>
        <p:spPr>
          <a:xfrm>
            <a:off x="3284640" y="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B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3" name="Text Box 3"/>
          <p:cNvSpPr/>
          <p:nvPr/>
        </p:nvSpPr>
        <p:spPr>
          <a:xfrm>
            <a:off x="0" y="8532720"/>
            <a:ext cx="685800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S7 Fig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Expression levels of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Dio1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(A) an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Dio3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(B) in kidneys of 7-, 15-, and 18-day-old WT an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Csb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m/m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/Xpa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-/-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mice. Expression levels of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Dio1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(C) an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Dio3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(D) in kidneys of 16-week-old WT an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Ercc1</a:t>
            </a:r>
            <a:r>
              <a:rPr b="0" i="1" lang="en-US" sz="1100" spc="-1" strike="noStrike" baseline="30000">
                <a:solidFill>
                  <a:srgbClr val="000000"/>
                </a:solidFill>
                <a:latin typeface="Arial"/>
                <a:ea typeface="Lucida Sans Unicode"/>
              </a:rPr>
              <a:t>-/Δ-7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mice. Values represent mean ± SE. * P &lt; 0.05; ** P &lt; 0.01. # P = 0.05.</a:t>
            </a:r>
            <a:endParaRPr b="0" lang="en-US" sz="11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44" name="Picture 5" descr=""/>
          <p:cNvPicPr/>
          <p:nvPr/>
        </p:nvPicPr>
        <p:blipFill>
          <a:blip r:embed="rId1"/>
          <a:stretch/>
        </p:blipFill>
        <p:spPr>
          <a:xfrm>
            <a:off x="0" y="0"/>
            <a:ext cx="3048120" cy="2600280"/>
          </a:xfrm>
          <a:prstGeom prst="rect">
            <a:avLst/>
          </a:prstGeom>
          <a:ln w="0">
            <a:noFill/>
          </a:ln>
        </p:spPr>
      </p:pic>
      <p:sp>
        <p:nvSpPr>
          <p:cNvPr id="45" name="Text Box 6"/>
          <p:cNvSpPr/>
          <p:nvPr/>
        </p:nvSpPr>
        <p:spPr>
          <a:xfrm>
            <a:off x="2158920" y="1614600"/>
            <a:ext cx="37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6" name="Text Box 7"/>
          <p:cNvSpPr/>
          <p:nvPr/>
        </p:nvSpPr>
        <p:spPr>
          <a:xfrm>
            <a:off x="2484360" y="1577880"/>
            <a:ext cx="37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#</a:t>
            </a:r>
            <a:endParaRPr b="0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7" name="Text Box 8"/>
          <p:cNvSpPr/>
          <p:nvPr/>
        </p:nvSpPr>
        <p:spPr>
          <a:xfrm>
            <a:off x="4964040" y="4449600"/>
            <a:ext cx="5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8" name="Line 9"/>
          <p:cNvSpPr/>
          <p:nvPr/>
        </p:nvSpPr>
        <p:spPr>
          <a:xfrm flipH="1">
            <a:off x="4749840" y="4643280"/>
            <a:ext cx="8143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pic>
        <p:nvPicPr>
          <p:cNvPr id="49" name="Picture 10" descr=""/>
          <p:cNvPicPr/>
          <p:nvPr/>
        </p:nvPicPr>
        <p:blipFill>
          <a:blip r:embed="rId2"/>
          <a:stretch/>
        </p:blipFill>
        <p:spPr>
          <a:xfrm>
            <a:off x="3141720" y="0"/>
            <a:ext cx="3057480" cy="26100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11" descr=""/>
          <p:cNvPicPr/>
          <p:nvPr/>
        </p:nvPicPr>
        <p:blipFill>
          <a:blip r:embed="rId3"/>
          <a:stretch/>
        </p:blipFill>
        <p:spPr>
          <a:xfrm>
            <a:off x="3708360" y="4211640"/>
            <a:ext cx="2457360" cy="277164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12" descr=""/>
          <p:cNvPicPr/>
          <p:nvPr/>
        </p:nvPicPr>
        <p:blipFill>
          <a:blip r:embed="rId4"/>
          <a:stretch/>
        </p:blipFill>
        <p:spPr>
          <a:xfrm>
            <a:off x="44280" y="4224240"/>
            <a:ext cx="2448000" cy="2762280"/>
          </a:xfrm>
          <a:prstGeom prst="rect">
            <a:avLst/>
          </a:prstGeom>
          <a:ln w="0">
            <a:noFill/>
          </a:ln>
        </p:spPr>
      </p:pic>
      <p:sp>
        <p:nvSpPr>
          <p:cNvPr id="52" name="Text Box 13"/>
          <p:cNvSpPr/>
          <p:nvPr/>
        </p:nvSpPr>
        <p:spPr>
          <a:xfrm>
            <a:off x="1397160" y="4452840"/>
            <a:ext cx="50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3" name="Line 14"/>
          <p:cNvSpPr/>
          <p:nvPr/>
        </p:nvSpPr>
        <p:spPr>
          <a:xfrm flipH="1">
            <a:off x="1182600" y="4646520"/>
            <a:ext cx="8143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grpSp>
        <p:nvGrpSpPr>
          <p:cNvPr id="54" name="Group 16"/>
          <p:cNvGrpSpPr/>
          <p:nvPr/>
        </p:nvGrpSpPr>
        <p:grpSpPr>
          <a:xfrm>
            <a:off x="5938920" y="539640"/>
            <a:ext cx="899640" cy="647640"/>
            <a:chOff x="5938920" y="539640"/>
            <a:chExt cx="899640" cy="647640"/>
          </a:xfrm>
        </p:grpSpPr>
        <p:sp>
          <p:nvSpPr>
            <p:cNvPr id="55" name="AutoShape 17"/>
            <p:cNvSpPr/>
            <p:nvPr/>
          </p:nvSpPr>
          <p:spPr>
            <a:xfrm>
              <a:off x="5938920" y="539640"/>
              <a:ext cx="503280" cy="64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6" name="Rectangle 18"/>
            <p:cNvSpPr/>
            <p:nvPr/>
          </p:nvSpPr>
          <p:spPr>
            <a:xfrm>
              <a:off x="5983200" y="614160"/>
              <a:ext cx="509760" cy="419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7" name="Rectangle 19"/>
            <p:cNvSpPr/>
            <p:nvPr/>
          </p:nvSpPr>
          <p:spPr>
            <a:xfrm>
              <a:off x="6032520" y="690480"/>
              <a:ext cx="76320" cy="75960"/>
            </a:xfrm>
            <a:prstGeom prst="rect">
              <a:avLst/>
            </a:prstGeom>
            <a:solidFill>
              <a:srgbClr val="33cccc"/>
            </a:solidFill>
            <a:ln w="9360">
              <a:solidFill>
                <a:srgbClr val="33cc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8" name="Rectangle 20"/>
            <p:cNvSpPr/>
            <p:nvPr/>
          </p:nvSpPr>
          <p:spPr>
            <a:xfrm>
              <a:off x="6137640" y="642600"/>
              <a:ext cx="19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lang="nl-NL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9" name="Oval 21"/>
            <p:cNvSpPr/>
            <p:nvPr/>
          </p:nvSpPr>
          <p:spPr>
            <a:xfrm>
              <a:off x="6032520" y="890280"/>
              <a:ext cx="76320" cy="7632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0" name="Rectangle 22"/>
            <p:cNvSpPr/>
            <p:nvPr/>
          </p:nvSpPr>
          <p:spPr>
            <a:xfrm>
              <a:off x="6156360" y="842760"/>
              <a:ext cx="682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sb</a:t>
              </a:r>
              <a:r>
                <a:rPr b="1" i="1" lang="en-US" sz="1000" spc="-1" strike="noStrike" baseline="30000">
                  <a:solidFill>
                    <a:srgbClr val="000000"/>
                  </a:solidFill>
                  <a:latin typeface="Arial"/>
                  <a:ea typeface="Times New Roman"/>
                </a:rPr>
                <a:t>m/m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/Xpa</a:t>
              </a:r>
              <a:r>
                <a:rPr b="1" i="1" lang="en-US" sz="1000" spc="-1" strike="noStrike" baseline="30000">
                  <a:solidFill>
                    <a:srgbClr val="000000"/>
                  </a:solidFill>
                  <a:latin typeface="Arial"/>
                  <a:ea typeface="Times New Roman"/>
                </a:rPr>
                <a:t>-</a:t>
              </a:r>
              <a:endParaRPr b="0" lang="en-US" sz="1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  <p:sp>
        <p:nvSpPr>
          <p:cNvPr id="61" name="Text Box 23"/>
          <p:cNvSpPr/>
          <p:nvPr/>
        </p:nvSpPr>
        <p:spPr>
          <a:xfrm>
            <a:off x="-20520" y="414036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C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2" name="Text Box 24"/>
          <p:cNvSpPr/>
          <p:nvPr/>
        </p:nvSpPr>
        <p:spPr>
          <a:xfrm>
            <a:off x="3263760" y="4140360"/>
            <a:ext cx="38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D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09T09:26:31Z</dcterms:created>
  <dc:creator>USER</dc:creator>
  <dc:description/>
  <dc:language>en-US</dc:language>
  <cp:lastModifiedBy>Edward Visser</cp:lastModifiedBy>
  <dcterms:modified xsi:type="dcterms:W3CDTF">2016-02-11T12:46:11Z</dcterms:modified>
  <cp:revision>111</cp:revision>
  <dc:subject/>
  <dc:title>PowerPoint Presentation</dc:title>
</cp:coreProperties>
</file>